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>
        <p:scale>
          <a:sx n="70" d="100"/>
          <a:sy n="70" d="100"/>
        </p:scale>
        <p:origin x="2357" y="-590"/>
      </p:cViewPr>
      <p:guideLst>
        <p:guide orient="horz" pos="576"/>
        <p:guide pos="1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C440DA-989F-424F-AC98-F8222F905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993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29C70736-E066-49C3-8C7B-D6CD53B9536B}"/>
              </a:ext>
            </a:extLst>
          </p:cNvPr>
          <p:cNvSpPr txBox="1"/>
          <p:nvPr/>
        </p:nvSpPr>
        <p:spPr>
          <a:xfrm>
            <a:off x="530684" y="2115093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B9AA98D-79B6-4A8A-A576-89100B4E5743}"/>
              </a:ext>
            </a:extLst>
          </p:cNvPr>
          <p:cNvSpPr txBox="1"/>
          <p:nvPr/>
        </p:nvSpPr>
        <p:spPr>
          <a:xfrm>
            <a:off x="544537" y="1829429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3F17ED3-2EED-4465-B263-E05A3F5340E4}"/>
              </a:ext>
            </a:extLst>
          </p:cNvPr>
          <p:cNvSpPr txBox="1"/>
          <p:nvPr/>
        </p:nvSpPr>
        <p:spPr>
          <a:xfrm>
            <a:off x="541637" y="1509830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012BBCF-A9FA-4FFE-ABA4-DDB34A24147C}"/>
              </a:ext>
            </a:extLst>
          </p:cNvPr>
          <p:cNvSpPr txBox="1"/>
          <p:nvPr/>
        </p:nvSpPr>
        <p:spPr>
          <a:xfrm>
            <a:off x="552580" y="873573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5AEE380-1989-4364-813B-024198194B3B}"/>
              </a:ext>
            </a:extLst>
          </p:cNvPr>
          <p:cNvSpPr txBox="1"/>
          <p:nvPr/>
        </p:nvSpPr>
        <p:spPr>
          <a:xfrm rot="16200000">
            <a:off x="-256122" y="1723843"/>
            <a:ext cx="16729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-SHP09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39F7BD6-0060-4109-82E7-5E5D6AA23E7D}"/>
              </a:ext>
            </a:extLst>
          </p:cNvPr>
          <p:cNvSpPr txBox="1"/>
          <p:nvPr/>
        </p:nvSpPr>
        <p:spPr>
          <a:xfrm rot="19917509">
            <a:off x="470205" y="2448181"/>
            <a:ext cx="138995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w Neuregulin-1 RNA Expression (n=20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4E89673-E216-47A1-8F82-FAE6F77E3E05}"/>
              </a:ext>
            </a:extLst>
          </p:cNvPr>
          <p:cNvSpPr txBox="1"/>
          <p:nvPr/>
        </p:nvSpPr>
        <p:spPr>
          <a:xfrm rot="19767681">
            <a:off x="899830" y="2625879"/>
            <a:ext cx="17926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gh Neuregulin-1 RNA Expression (n=20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BACD8F7-5627-44AA-8488-7E1673DF450E}"/>
              </a:ext>
            </a:extLst>
          </p:cNvPr>
          <p:cNvSpPr txBox="1"/>
          <p:nvPr/>
        </p:nvSpPr>
        <p:spPr>
          <a:xfrm>
            <a:off x="541637" y="1189976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023AC4-3A18-4853-B954-CCA1DD068309}"/>
              </a:ext>
            </a:extLst>
          </p:cNvPr>
          <p:cNvSpPr txBox="1"/>
          <p:nvPr/>
        </p:nvSpPr>
        <p:spPr>
          <a:xfrm>
            <a:off x="3834726" y="2151309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63B2D6B-9271-4A26-AF83-AE182C45A4A1}"/>
              </a:ext>
            </a:extLst>
          </p:cNvPr>
          <p:cNvSpPr txBox="1"/>
          <p:nvPr/>
        </p:nvSpPr>
        <p:spPr>
          <a:xfrm>
            <a:off x="3847830" y="1843164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D95000B-3EBE-48A7-8465-5AC4CF5E782C}"/>
              </a:ext>
            </a:extLst>
          </p:cNvPr>
          <p:cNvSpPr txBox="1"/>
          <p:nvPr/>
        </p:nvSpPr>
        <p:spPr>
          <a:xfrm>
            <a:off x="3840456" y="1530939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CF52B87-96F1-4318-A400-7D8AD3C2112D}"/>
              </a:ext>
            </a:extLst>
          </p:cNvPr>
          <p:cNvSpPr txBox="1"/>
          <p:nvPr/>
        </p:nvSpPr>
        <p:spPr>
          <a:xfrm>
            <a:off x="3841156" y="899840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9E4E16A-4E36-42BF-8DEC-F9C173148EBC}"/>
              </a:ext>
            </a:extLst>
          </p:cNvPr>
          <p:cNvSpPr txBox="1"/>
          <p:nvPr/>
        </p:nvSpPr>
        <p:spPr>
          <a:xfrm rot="16200000">
            <a:off x="3052070" y="1722643"/>
            <a:ext cx="16729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-SHP099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373D2FF-F6D4-4AC9-820E-3FA6F83A0A02}"/>
              </a:ext>
            </a:extLst>
          </p:cNvPr>
          <p:cNvSpPr txBox="1"/>
          <p:nvPr/>
        </p:nvSpPr>
        <p:spPr>
          <a:xfrm rot="19917509">
            <a:off x="3860908" y="2506706"/>
            <a:ext cx="13233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w EGF RNA Expression (n=20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E90C95B-30C3-4C10-8244-8C3578F73821}"/>
              </a:ext>
            </a:extLst>
          </p:cNvPr>
          <p:cNvSpPr txBox="1"/>
          <p:nvPr/>
        </p:nvSpPr>
        <p:spPr>
          <a:xfrm rot="19767681">
            <a:off x="4652696" y="2550304"/>
            <a:ext cx="13580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gh EGF RNA Expression (n=20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66EDEAF-B550-4E95-BF98-13A8BB38D898}"/>
              </a:ext>
            </a:extLst>
          </p:cNvPr>
          <p:cNvSpPr txBox="1"/>
          <p:nvPr/>
        </p:nvSpPr>
        <p:spPr>
          <a:xfrm>
            <a:off x="3840456" y="1216308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CFD61EF-BBCA-4EDC-A663-2735727445F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11849" t="13217" r="30774" b="25522"/>
          <a:stretch/>
        </p:blipFill>
        <p:spPr>
          <a:xfrm>
            <a:off x="1120544" y="914910"/>
            <a:ext cx="1792224" cy="14081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295D3E5-E7FB-4C07-9C02-C7013B8EF94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12099" t="12389" r="31324" b="26742"/>
          <a:stretch/>
        </p:blipFill>
        <p:spPr>
          <a:xfrm>
            <a:off x="4421607" y="914910"/>
            <a:ext cx="1792224" cy="14081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5F69E92-8EB4-4D3A-9433-02502F73766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11956" t="13591" r="32626" b="25193"/>
          <a:stretch/>
        </p:blipFill>
        <p:spPr>
          <a:xfrm>
            <a:off x="1099678" y="3560864"/>
            <a:ext cx="1792224" cy="1408176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C48364C7-9A12-4145-9D88-66B5929F4BB8}"/>
              </a:ext>
            </a:extLst>
          </p:cNvPr>
          <p:cNvSpPr txBox="1"/>
          <p:nvPr/>
        </p:nvSpPr>
        <p:spPr>
          <a:xfrm>
            <a:off x="524587" y="4764453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29AC94B-F8EB-424A-95D1-612CC7B5AC36}"/>
              </a:ext>
            </a:extLst>
          </p:cNvPr>
          <p:cNvSpPr txBox="1"/>
          <p:nvPr/>
        </p:nvSpPr>
        <p:spPr>
          <a:xfrm>
            <a:off x="531066" y="4465149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16E246F-E047-4045-AA0E-56AB350BD0C9}"/>
              </a:ext>
            </a:extLst>
          </p:cNvPr>
          <p:cNvSpPr txBox="1"/>
          <p:nvPr/>
        </p:nvSpPr>
        <p:spPr>
          <a:xfrm>
            <a:off x="522943" y="4149665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99D87C8-0E9D-4B8A-92D4-08E7A66C9798}"/>
              </a:ext>
            </a:extLst>
          </p:cNvPr>
          <p:cNvSpPr txBox="1"/>
          <p:nvPr/>
        </p:nvSpPr>
        <p:spPr>
          <a:xfrm>
            <a:off x="533917" y="3516480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1E0C596-BE89-4F10-9E2B-270CC0885E4C}"/>
              </a:ext>
            </a:extLst>
          </p:cNvPr>
          <p:cNvSpPr txBox="1"/>
          <p:nvPr/>
        </p:nvSpPr>
        <p:spPr>
          <a:xfrm rot="16200000">
            <a:off x="-250844" y="4410024"/>
            <a:ext cx="16729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-SHP099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6AA51A5-79E5-4650-B182-8C8243782762}"/>
              </a:ext>
            </a:extLst>
          </p:cNvPr>
          <p:cNvSpPr txBox="1"/>
          <p:nvPr/>
        </p:nvSpPr>
        <p:spPr>
          <a:xfrm rot="19917509">
            <a:off x="123164" y="5196952"/>
            <a:ext cx="17042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phiregul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Expression (n=20)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681A86F-7B42-49BF-B73F-52E40EBD54D4}"/>
              </a:ext>
            </a:extLst>
          </p:cNvPr>
          <p:cNvSpPr txBox="1"/>
          <p:nvPr/>
        </p:nvSpPr>
        <p:spPr>
          <a:xfrm rot="19767681">
            <a:off x="919904" y="5280189"/>
            <a:ext cx="18122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phiregul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Expression (n=20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3453389-2AF8-491E-8379-22307AE7EDEC}"/>
              </a:ext>
            </a:extLst>
          </p:cNvPr>
          <p:cNvSpPr txBox="1"/>
          <p:nvPr/>
        </p:nvSpPr>
        <p:spPr>
          <a:xfrm>
            <a:off x="531066" y="3830950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F49C426-6C80-48BA-8C61-330B836B8F52}"/>
              </a:ext>
            </a:extLst>
          </p:cNvPr>
          <p:cNvSpPr txBox="1"/>
          <p:nvPr/>
        </p:nvSpPr>
        <p:spPr>
          <a:xfrm>
            <a:off x="1858339" y="564576"/>
            <a:ext cx="923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NS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/>
          <p:cNvCxnSpPr/>
          <p:nvPr/>
        </p:nvCxnSpPr>
        <p:spPr>
          <a:xfrm>
            <a:off x="1705046" y="750869"/>
            <a:ext cx="878609" cy="76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V="1">
            <a:off x="1715136" y="755675"/>
            <a:ext cx="0" cy="124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V="1">
            <a:off x="2578631" y="750869"/>
            <a:ext cx="0" cy="1177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8F49C426-6C80-48BA-8C61-330B836B8F52}"/>
              </a:ext>
            </a:extLst>
          </p:cNvPr>
          <p:cNvSpPr txBox="1"/>
          <p:nvPr/>
        </p:nvSpPr>
        <p:spPr>
          <a:xfrm>
            <a:off x="5164355" y="567584"/>
            <a:ext cx="6822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NS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/>
          <p:cNvCxnSpPr/>
          <p:nvPr/>
        </p:nvCxnSpPr>
        <p:spPr>
          <a:xfrm>
            <a:off x="4993991" y="761575"/>
            <a:ext cx="8744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V="1">
            <a:off x="5000010" y="748051"/>
            <a:ext cx="0" cy="124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 flipV="1">
            <a:off x="5858067" y="748561"/>
            <a:ext cx="0" cy="1177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8F49C426-6C80-48BA-8C61-330B836B8F52}"/>
              </a:ext>
            </a:extLst>
          </p:cNvPr>
          <p:cNvSpPr txBox="1"/>
          <p:nvPr/>
        </p:nvSpPr>
        <p:spPr>
          <a:xfrm>
            <a:off x="1832545" y="3233651"/>
            <a:ext cx="923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NS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94"/>
          <p:cNvCxnSpPr/>
          <p:nvPr/>
        </p:nvCxnSpPr>
        <p:spPr>
          <a:xfrm>
            <a:off x="1694116" y="3418790"/>
            <a:ext cx="869061" cy="88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 flipV="1">
            <a:off x="1705290" y="3419434"/>
            <a:ext cx="0" cy="124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 flipV="1">
            <a:off x="2558153" y="3419944"/>
            <a:ext cx="0" cy="1177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58964109-6DCC-0FA5-4152-14AD1183471A}"/>
              </a:ext>
            </a:extLst>
          </p:cNvPr>
          <p:cNvSpPr txBox="1"/>
          <p:nvPr/>
        </p:nvSpPr>
        <p:spPr>
          <a:xfrm>
            <a:off x="111118" y="6075386"/>
            <a:ext cx="656556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7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TK ligand expression in HNSCC cell lines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NSC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cell lines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rom the GDSC database were clustered into low and high Neuregulin-1, EGF, and Amphiregulin RNA expression, and the SHP099 AUC data for these cell lines were plotted. The red bars indicate the means of each group. Statistical significance was determined using two-tailed Student’s t-test. p value= not significant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04757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5</TotalTime>
  <Words>152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49</cp:revision>
  <cp:lastPrinted>2019-09-23T20:12:05Z</cp:lastPrinted>
  <dcterms:created xsi:type="dcterms:W3CDTF">2019-03-07T03:13:48Z</dcterms:created>
  <dcterms:modified xsi:type="dcterms:W3CDTF">2022-07-07T10:48:14Z</dcterms:modified>
</cp:coreProperties>
</file>